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uis Miguel Rodriguez Rojas" initials="" lastIdx="7" clrIdx="0"/>
  <p:cmAuthor id="1" name="Kwanho Jeong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FF8AD8"/>
    <a:srgbClr val="FF66FF"/>
    <a:srgbClr val="9437FF"/>
    <a:srgbClr val="FFFD78"/>
    <a:srgbClr val="FFD579"/>
    <a:srgbClr val="FF7E79"/>
    <a:srgbClr val="FF3300"/>
    <a:srgbClr val="FF0000"/>
    <a:srgbClr val="00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4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00" y="11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7D9BDA-C7E9-8B41-9786-0430BC53980E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036F3-367B-5C45-AB7C-27BFD8CC37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7627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524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705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217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74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821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782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2940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8712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2479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241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5834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3134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806024" y="5090677"/>
            <a:ext cx="6120000" cy="10152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 S3. </a:t>
            </a:r>
            <a:r>
              <a:rPr lang="fr-FR" sz="1200" b="1" dirty="0">
                <a:latin typeface="Times New Roman"/>
                <a:cs typeface="Times New Roman"/>
              </a:rPr>
              <a:t>Structure of the CRISPR </a:t>
            </a:r>
            <a:r>
              <a:rPr lang="fr-FR" sz="1200" b="1" dirty="0" err="1">
                <a:latin typeface="Times New Roman"/>
                <a:cs typeface="Times New Roman"/>
              </a:rPr>
              <a:t>array</a:t>
            </a:r>
            <a:r>
              <a:rPr lang="fr-FR" sz="1200" b="1" dirty="0">
                <a:latin typeface="Times New Roman"/>
                <a:cs typeface="Times New Roman"/>
              </a:rPr>
              <a:t> of </a:t>
            </a:r>
            <a:r>
              <a:rPr lang="fr-F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 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strain</a:t>
            </a:r>
            <a:r>
              <a:rPr lang="fr-FR" sz="1200" b="1" dirty="0">
                <a:latin typeface="Times New Roman"/>
                <a:cs typeface="Times New Roman"/>
              </a:rPr>
              <a:t> NCPPB 3608. </a:t>
            </a:r>
            <a:r>
              <a:rPr lang="en-US" sz="1200" dirty="0">
                <a:latin typeface="Times New Roman"/>
                <a:cs typeface="Times New Roman"/>
              </a:rPr>
              <a:t>Red characters indicate direct repeat sequences, </a:t>
            </a:r>
            <a:r>
              <a:rPr lang="fr-FR" sz="1200" dirty="0" err="1">
                <a:latin typeface="Times New Roman"/>
                <a:cs typeface="Times New Roman"/>
              </a:rPr>
              <a:t>with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SNP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underlined</a:t>
            </a:r>
            <a:r>
              <a:rPr lang="en-US" sz="1200" dirty="0">
                <a:latin typeface="Times New Roman"/>
                <a:cs typeface="Times New Roman"/>
              </a:rPr>
              <a:t>. Blue characters indicate spacer sequences. 6 </a:t>
            </a:r>
            <a:r>
              <a:rPr lang="en-US" sz="1200" dirty="0" err="1">
                <a:latin typeface="Times New Roman"/>
                <a:cs typeface="Times New Roman"/>
              </a:rPr>
              <a:t>bp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dirty="0" err="1">
                <a:latin typeface="Times New Roman"/>
                <a:cs typeface="Times New Roman"/>
              </a:rPr>
              <a:t>tgaaac</a:t>
            </a:r>
            <a:r>
              <a:rPr lang="en-US" sz="1200" dirty="0">
                <a:latin typeface="Times New Roman"/>
                <a:cs typeface="Times New Roman"/>
              </a:rPr>
              <a:t>) in green boxes represent the target site duplication. Pink boxes represent the inverted repeats (28 </a:t>
            </a:r>
            <a:r>
              <a:rPr lang="en-US" sz="1200" dirty="0" err="1">
                <a:latin typeface="Times New Roman"/>
                <a:cs typeface="Times New Roman"/>
              </a:rPr>
              <a:t>bp</a:t>
            </a:r>
            <a:r>
              <a:rPr lang="en-US" sz="1200" dirty="0">
                <a:latin typeface="Times New Roman"/>
                <a:cs typeface="Times New Roman"/>
              </a:rPr>
              <a:t>). Blue boxes represent base pairs that do not match within the inverted repeats. 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806024" y="735777"/>
            <a:ext cx="6120000" cy="4247317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aatgctttcgacgcgcataaagcgctggcgcagg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3)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ttcaagctccgccgcctgatccgcttgccgag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2)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cgggtttcgggatgtgcttcagatctgcgtcg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1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  <a:tabLst>
                <a:tab pos="1890395" algn="l"/>
              </a:tabLst>
            </a:pP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</a:t>
            </a:r>
            <a:r>
              <a:rPr lang="en-US" sz="900" dirty="0" err="1">
                <a:solidFill>
                  <a:srgbClr val="FF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aaac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t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gccgat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aaa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acccac</a:t>
            </a:r>
            <a:endParaRPr lang="en-US" sz="900" dirty="0">
              <a:highlight>
                <a:srgbClr val="FF00FF"/>
              </a:highlight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  <a:tabLst>
                <a:tab pos="1890395" algn="l"/>
              </a:tabLst>
            </a:pPr>
            <a:r>
              <a:rPr lang="en-US" sz="900" dirty="0" err="1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gcgccgaagtaaaagt</a:t>
            </a:r>
            <a:endParaRPr lang="en-US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  <a:tabLst>
                <a:tab pos="1890395" algn="l"/>
              </a:tabLst>
            </a:pPr>
            <a:endParaRPr lang="en-US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  <a:tabLst>
                <a:tab pos="1890395" algn="l"/>
              </a:tabLst>
            </a:pPr>
            <a:r>
              <a:rPr lang="en-US" sz="900" dirty="0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... IS element ... </a:t>
            </a:r>
          </a:p>
          <a:p>
            <a:pPr>
              <a:spcAft>
                <a:spcPts val="0"/>
              </a:spcAft>
              <a:tabLst>
                <a:tab pos="1890395" algn="l"/>
              </a:tabLst>
            </a:pP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  <a:tabLst>
                <a:tab pos="1890395" algn="l"/>
              </a:tabLst>
            </a:pPr>
            <a:r>
              <a:rPr lang="fr-FR" sz="900" dirty="0" err="1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ggcgatccaacgaaaa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  <a:tabLst>
                <a:tab pos="1890395" algn="l"/>
              </a:tabLst>
            </a:pPr>
            <a:r>
              <a:rPr lang="en-US" sz="900" dirty="0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gggtcag</a:t>
            </a:r>
            <a:r>
              <a:rPr lang="en-US" sz="900" dirty="0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tta</a:t>
            </a:r>
            <a:r>
              <a:rPr lang="en-US" sz="900" dirty="0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tcggcg</a:t>
            </a:r>
            <a:r>
              <a:rPr lang="en-US" sz="900" dirty="0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ca</a:t>
            </a:r>
            <a:r>
              <a:rPr lang="en-US" sz="900" dirty="0">
                <a:solidFill>
                  <a:srgbClr val="FF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gctgcacggatgcgccaggcggcgaggcgatcat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0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gagcgcatcgatgacggtcacccatcccccaat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9)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gccaccgacagcgacgcacgtggacctgcagat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8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ctctcacgccgcgcgtgcgagatcctgcgtg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7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cagactgccgaggccggcatgctggaggggcgcct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6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ggttaacaacgccttgaaacggctttgccgcgacg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5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cgtcttggacctgggtgtggttgctgagatagtca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4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ccatcatgctttgaatgcgcttacccacggcgaa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3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cggatatgtgattagacccttttacgactttc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2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tgtcgaaaacgatggccttgacgtcatcgtctg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1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tcgctggcatcggtggatggagccttgcgcttc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0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attgaacccaaggaccacttcgcagggcgact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9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tgaccacatgttctctctgtgggaggaaggca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8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tcgagcgcgcactgctgccgcgatggccggaa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7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gctgggagcgttacaagtttgagcagcccgt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6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gttcagggctggaaagacttggatgcccgcat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5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actatccctgcataggccacgacctgcgag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4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agaagaccagtctgcggcgtcgcggcatcctggg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3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agttcgtcgccgtcccggtcgtctgacgcgt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u="sng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gcgccctca</a:t>
            </a:r>
            <a:r>
              <a:rPr lang="en-US" sz="900" u="sng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atgccatatgcggcgagatcgcacagcagaaggaa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u="sng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gcgccctcacgggcgcgtggattgaaac</a:t>
            </a:r>
            <a:endParaRPr lang="fr-FR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36344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72</TotalTime>
  <Words>170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Malgun Gothic</vt:lpstr>
      <vt:lpstr>Arial</vt:lpstr>
      <vt:lpstr>Calibri</vt:lpstr>
      <vt:lpstr>Calibri Light</vt:lpstr>
      <vt:lpstr>Courier New</vt:lpstr>
      <vt:lpstr>Times New Roman</vt:lpstr>
      <vt:lpstr>Thème Office</vt:lpstr>
      <vt:lpstr>PowerPoint Presentation</vt:lpstr>
    </vt:vector>
  </TitlesOfParts>
  <Company>IR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wanho JEONG</dc:creator>
  <cp:lastModifiedBy>Microsoft Office User</cp:lastModifiedBy>
  <cp:revision>124</cp:revision>
  <cp:lastPrinted>2018-08-27T13:01:04Z</cp:lastPrinted>
  <dcterms:created xsi:type="dcterms:W3CDTF">2018-03-26T14:17:04Z</dcterms:created>
  <dcterms:modified xsi:type="dcterms:W3CDTF">2019-11-04T14:10:41Z</dcterms:modified>
</cp:coreProperties>
</file>